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16650" cy="8686800"/>
  <p:notesSz cx="5943600" cy="82296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58DD5-19CB-4A00-B1B2-EC3E7761A9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19488-0613-4B12-8E41-846FE631C9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7674CE-5A7A-43D7-9ECA-381670BA2F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0284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9536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068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0284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9536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CAB43-C8EC-4162-8DD6-8683DA55D3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826E77-965B-4436-B676-CE5D8AE84D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06073-FA62-48C2-9096-5B28BF4B0F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E43D8-00C5-49B0-96E7-99BB1956D7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9C49DD-63D7-41F1-A102-58BD84A796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0680" y="347400"/>
            <a:ext cx="5596200" cy="671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EE021-68D4-483D-8334-0B2E1F9B65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25F8D-2205-4DE7-8E2E-01ACB2EE59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E02DD-32A2-4EBC-9D50-80D438C3B5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50313C-963F-40E7-80C3-AF2FD42636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068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23640" y="8051400"/>
            <a:ext cx="197028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5572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D2E3DA-7ED0-4287-83BA-02F905C630B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0" y="297720"/>
            <a:ext cx="621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    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Table S5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"/>
          <p:cNvSpPr/>
          <p:nvPr/>
        </p:nvSpPr>
        <p:spPr>
          <a:xfrm>
            <a:off x="0" y="5793480"/>
            <a:ext cx="621828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Calibri"/>
              </a:rPr>
              <a:t>Effect of Bezafibrate intervention (200 and 400 µmol/L in SCADD fibroblasts only) on menadione toxicity in each FAO disorder under variable conditions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Calibri"/>
              </a:rPr>
              <a:t>. Paired t-test compares each FAOD with and without Bezafibrate, under each experimental condition, after logarithmic transformation of data.  ^ p&lt;0.05 * p&lt;0.01 ** p&lt;0.001 *** p&lt;0.0005 **** p&lt;0.0001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290520" y="838080"/>
          <a:ext cx="5668920" cy="4721400"/>
        </p:xfrm>
        <a:graphic>
          <a:graphicData uri="http://schemas.openxmlformats.org/drawingml/2006/table">
            <a:tbl>
              <a:tblPr/>
              <a:tblGrid>
                <a:gridCol w="1219320"/>
                <a:gridCol w="1143000"/>
                <a:gridCol w="1143000"/>
                <a:gridCol w="1143000"/>
                <a:gridCol w="1020600"/>
              </a:tblGrid>
              <a:tr h="55080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μM Menadion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hysiological condi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° C,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C with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,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(n=1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.2 ± 8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.9 ± 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.9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.7 ± 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5044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200μmol/L Bezafib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1.2 ± 7.4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4.4 ± 6.8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6.6 ± 6.8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7.5 ± 5.6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5044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400μmol/L Bezafib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4.6 ± 7.4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7.41 ± 6.7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.5 ± 6.3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.4 ± 5.4*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808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792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(n=1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.9 ± 1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1 ± 10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.3 ± 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6.6 ± 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524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+ 200μmol/L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Bezafib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31.6 ± 26.4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73.5 ± 26.3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1.2 ± 10.5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8.1 ± 16.1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05.2 ± 11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7.2 ± 17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6.0 ± 11.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0.5 ± 20.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524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+ 200μmol/L Bezafib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7.5 ± 5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0.0 ± 24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4.5 ± 13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8.50 ± 21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(n-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8.4 ± 9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4 ± 8.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1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83 ± 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5240"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+ 200μmol/L Bezafibra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8.4 ± 9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2 ± 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1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3840" rIns="338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4.17 ± 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3840" marR="338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1T22:39:26Z</dcterms:created>
  <dc:creator>keith cunningham</dc:creator>
  <dc:description/>
  <dc:language>en-US</dc:language>
  <cp:lastModifiedBy>Ingrid Tein</cp:lastModifiedBy>
  <cp:lastPrinted>2011-01-27T01:12:00Z</cp:lastPrinted>
  <dcterms:modified xsi:type="dcterms:W3CDTF">2011-02-25T22:39:02Z</dcterms:modified>
  <cp:revision>32</cp:revision>
  <dc:subject/>
  <dc:title>Slide 1</dc:title>
</cp:coreProperties>
</file>